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618" r:id="rId2"/>
    <p:sldId id="612" r:id="rId3"/>
    <p:sldId id="608" r:id="rId4"/>
    <p:sldId id="605" r:id="rId5"/>
    <p:sldId id="621" r:id="rId6"/>
    <p:sldId id="622" r:id="rId7"/>
  </p:sldIdLst>
  <p:sldSz cx="9144000" cy="6858000" type="screen4x3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00000"/>
    <a:srgbClr val="EAEAEA"/>
    <a:srgbClr val="09A72F"/>
    <a:srgbClr val="FF99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中度样式 3 - 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1832" autoAdjust="0"/>
  </p:normalViewPr>
  <p:slideViewPr>
    <p:cSldViewPr snapToGrid="0">
      <p:cViewPr>
        <p:scale>
          <a:sx n="52" d="100"/>
          <a:sy n="52" d="100"/>
        </p:scale>
        <p:origin x="1683" y="28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4122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DF9776-34E3-4B9C-89A2-620BE2403D99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995363" y="768350"/>
            <a:ext cx="5113337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860925"/>
            <a:ext cx="5683250" cy="4605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956B14-2A6D-4E89-9A78-4DD1925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81402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28650" y="365125"/>
            <a:ext cx="7886700" cy="5811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标题 1"/>
          <p:cNvSpPr>
            <a:spLocks noGrp="1"/>
          </p:cNvSpPr>
          <p:nvPr>
            <p:ph type="title"/>
          </p:nvPr>
        </p:nvSpPr>
        <p:spPr>
          <a:xfrm>
            <a:off x="193149" y="204243"/>
            <a:ext cx="5656505" cy="286232"/>
          </a:xfrm>
        </p:spPr>
        <p:txBody>
          <a:bodyPr wrap="none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Table S1. </a:t>
            </a:r>
            <a:endParaRPr lang="zh-CN" altLang="en-US" sz="2000" dirty="0">
              <a:latin typeface="Times New Roman" panose="02020603050405020304" pitchFamily="18" charset="0"/>
              <a:ea typeface="等线" panose="02010600030101010101" pitchFamily="2" charset="-122"/>
              <a:cs typeface="+mn-cs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573D9A3E-6D85-44FF-AB63-65DAFBB378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247839"/>
              </p:ext>
            </p:extLst>
          </p:nvPr>
        </p:nvGraphicFramePr>
        <p:xfrm>
          <a:off x="1368375" y="264385"/>
          <a:ext cx="7475131" cy="6389372"/>
        </p:xfrm>
        <a:graphic>
          <a:graphicData uri="http://schemas.openxmlformats.org/drawingml/2006/table">
            <a:tbl>
              <a:tblPr/>
              <a:tblGrid>
                <a:gridCol w="87699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7116">
                  <a:extLst>
                    <a:ext uri="{9D8B030D-6E8A-4147-A177-3AD203B41FA5}">
                      <a16:colId xmlns:a16="http://schemas.microsoft.com/office/drawing/2014/main" val="3281720700"/>
                    </a:ext>
                  </a:extLst>
                </a:gridCol>
                <a:gridCol w="28618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591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2274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enes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rpose</a:t>
                      </a:r>
                      <a:endParaRPr lang="en-US" altLang="zh-CN" sz="10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 (5’</a:t>
                      </a:r>
                      <a:r>
                        <a:rPr lang="en-US" altLang="zh-CN" sz="10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’) </a:t>
                      </a:r>
                      <a:endParaRPr lang="zh-CN" sz="1000" b="0" kern="100" dirty="0"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41" marR="57141" marT="952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 (5’</a:t>
                      </a:r>
                      <a:r>
                        <a:rPr lang="en-US" altLang="zh-CN" sz="10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’) </a:t>
                      </a:r>
                      <a:endParaRPr lang="zh-CN" sz="1000" b="0" kern="100" dirty="0"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41" marR="57141" marT="952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2749">
                <a:tc rowSpan="5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toMYB115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ene cloning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ATGGGAAGGGCTCCTTGTTG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GTCATACCAGCAGTGACT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zh-CN" sz="1400" b="0" i="1" kern="100" dirty="0"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57150" marR="571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as9-T1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TCATCTAAGGTGGGTTTGCGTAG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AACCTACGCAAACCCACCTTAGA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2749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zh-CN" sz="1400" b="0" i="1" kern="100" dirty="0"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57150" marR="571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as9-T2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TTGGCATCTTCTCTGGGAGTCCA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AACTGGACTCCCAGAGAAGATGC 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2749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zh-CN" sz="1400" b="0" i="1" kern="100" dirty="0"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57150" marR="571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as9-T3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TTGGTATATCCAGGCTCACGGCG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AACCGCCGTGAGCCTGGATATAC 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2749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zh-CN" sz="1400" b="0" i="1" kern="100" dirty="0"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57150" marR="571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CATTGGAGGTCTTTGCC 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GTTACCGAGGAGGGAGTGC 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1" kern="100" dirty="0" err="1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Hyg</a:t>
                      </a:r>
                      <a:endParaRPr lang="zh-CN" alt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TCGGACGATTGCGTCGCATC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TGTCACGTTGCAAGACCTG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0036314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BD38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GAAGAGTCTGAAACCACAACAC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CTTGTTCAGTCGCTCATGTATG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LE14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AGCTCATTTTGTTTCTCACGAG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TTTGGCTAAGCTTGAAATCACG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4H2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AGCAAGATCCTGGTAAACGC	</a:t>
                      </a:r>
                      <a:endParaRPr lang="zh-CN" altLang="zh-CN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TGAGGTGTCAATCTTGGACTG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CL5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ATCCGAGGTGATCAGATCATG	</a:t>
                      </a:r>
                      <a:endParaRPr lang="zh-CN" altLang="zh-CN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ACAGCAGCATCAGATATCC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HCT1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TCAGCATGTAAGGCACGCGG</a:t>
                      </a:r>
                      <a:endParaRPr lang="zh-CN" altLang="zh-CN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TGCCAAAGTAACCAGGTGGAAGCGT</a:t>
                      </a:r>
                      <a:endParaRPr 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3H3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TCTACGCTTCAAGCTCCCACCA</a:t>
                      </a:r>
                      <a:endParaRPr lang="zh-CN" altLang="zh-CN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GAACCTCACAGGCTTGACG</a:t>
                      </a:r>
                      <a:endParaRPr 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3402745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F5H4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AGTCCAGCAAGAGCTCGCAG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CATAAGCATTGATCATCAC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9581815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F5H2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TGTGTCATGAAGCTCTTTAGC</a:t>
                      </a:r>
                      <a:endParaRPr lang="zh-CN" altLang="zh-CN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CCAACCCAGCCAAGGGAAG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1969489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OMT2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TTGAAGAATTGCTATGACGCCT</a:t>
                      </a:r>
                      <a:endParaRPr lang="zh-CN" altLang="zh-CN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AATGCACTCAACAAGTATCACCTTG</a:t>
                      </a:r>
                      <a:endParaRPr lang="zh-CN" altLang="en-US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925991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AL5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CAGGGAAGTTGATTGATCC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AGAGGCATACACTTTGCTTG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6270971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HI1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TGTGCTAGAGTCAATGATTGG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GAAAAGCTTGAGCCTGAAAT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010151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HS4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TCACTGTTGAGACTGTGGTG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ACTCCTTATTGGTGCTCTC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2053721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NR1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AGAGAAGCTCATCAGTGAG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GACGCTAGATTGCTTCAGC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1022089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AR3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CTCCAAGCAATCTGCTAAGCACT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TCATGGTGCCATTCTTGTTCGCTG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756834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DFR1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CAGCTTGGAGGACATGTTC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TGCGATTGGCATTCGTCTAG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1371129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FLS1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CCTCACCATTCTTGTGCCT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TTAGCCACCGTGGTTCTGTG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2677693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UFGT1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TGTCCGATCATGTAGCAGTC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CCATCCCACACTTCGTATG 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1599225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ESA4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TCCAGGTGTTCTTAGGTCACAGC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CAGCTGAAACTCGAATCAGTGC</a:t>
                      </a:r>
                      <a:endParaRPr lang="zh-CN" altLang="en-US" sz="1000" b="0" kern="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079677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ESA7</a:t>
                      </a:r>
                      <a:endParaRPr lang="zh-CN" alt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TGGTGTCAGATCAAGACCTGTG</a:t>
                      </a:r>
                      <a:endParaRPr lang="zh-CN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TCTTTGCGTCCCATCTTGCG</a:t>
                      </a:r>
                      <a:endParaRPr lang="zh-CN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1294758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T8D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AATTTATGGACGAAGTCAAGAACAC</a:t>
                      </a:r>
                      <a:endParaRPr lang="zh-CN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TGCTTCGGTATGCTACTTGATGCT</a:t>
                      </a:r>
                      <a:endParaRPr lang="zh-CN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6226234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T43B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AGCTCCACCAAGCTCTAA</a:t>
                      </a:r>
                      <a:endParaRPr lang="zh-CN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TGATCCAACTCTGCTTCGGG</a:t>
                      </a:r>
                      <a:endParaRPr lang="zh-CN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1776161"/>
                  </a:ext>
                </a:extLst>
              </a:tr>
              <a:tr h="22274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i="1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UBQ</a:t>
                      </a:r>
                      <a:endParaRPr lang="zh-CN" sz="1000" b="0" i="1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Q-PCR</a:t>
                      </a:r>
                      <a:endParaRPr lang="zh-CN" alt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TTGATTTTTGCTGGGAAGC 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1000" b="0" kern="100" dirty="0"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ATCTTGGCCTTCACGTTGT</a:t>
                      </a:r>
                      <a:endParaRPr lang="zh-CN" sz="1000" b="0" kern="100" dirty="0"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57150" marR="571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24938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692318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>
            <a:extLst>
              <a:ext uri="{FF2B5EF4-FFF2-40B4-BE49-F238E27FC236}">
                <a16:creationId xmlns:a16="http://schemas.microsoft.com/office/drawing/2014/main" id="{487C3346-8D32-4A34-95A6-AB1F82DD7330}"/>
              </a:ext>
            </a:extLst>
          </p:cNvPr>
          <p:cNvSpPr/>
          <p:nvPr/>
        </p:nvSpPr>
        <p:spPr>
          <a:xfrm>
            <a:off x="282696" y="264599"/>
            <a:ext cx="9252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ea typeface="等线" panose="02010600030101010101" pitchFamily="2" charset="-122"/>
              </a:rPr>
              <a:t>Fig. S1</a:t>
            </a:r>
            <a:endParaRPr lang="zh-CN" altLang="en-US" sz="2000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6851491C-61E2-4DC3-A4DE-57E01370993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0043" y="1045709"/>
            <a:ext cx="4297897" cy="45748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7132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D2F7764E-8A05-4AA2-A863-9C415AB5AA5C}"/>
              </a:ext>
            </a:extLst>
          </p:cNvPr>
          <p:cNvSpPr/>
          <p:nvPr/>
        </p:nvSpPr>
        <p:spPr>
          <a:xfrm>
            <a:off x="282696" y="264599"/>
            <a:ext cx="9252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ea typeface="等线" panose="02010600030101010101" pitchFamily="2" charset="-122"/>
              </a:rPr>
              <a:t>Fig. S2</a:t>
            </a:r>
            <a:endParaRPr lang="zh-CN" altLang="en-US" sz="2000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4C71D62-A0B1-496E-97F8-88D0E84924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6104" y="1072896"/>
            <a:ext cx="4431792" cy="4712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882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矩形 8">
            <a:extLst>
              <a:ext uri="{FF2B5EF4-FFF2-40B4-BE49-F238E27FC236}">
                <a16:creationId xmlns:a16="http://schemas.microsoft.com/office/drawing/2014/main" id="{BF26DE0E-A2C0-455B-B408-4BF4153B7285}"/>
              </a:ext>
            </a:extLst>
          </p:cNvPr>
          <p:cNvSpPr/>
          <p:nvPr/>
        </p:nvSpPr>
        <p:spPr>
          <a:xfrm>
            <a:off x="282696" y="264599"/>
            <a:ext cx="9252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ea typeface="等线" panose="02010600030101010101" pitchFamily="2" charset="-122"/>
              </a:rPr>
              <a:t>Fig. S3</a:t>
            </a:r>
            <a:endParaRPr lang="zh-CN" altLang="en-US" sz="2000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B6F23085-D330-4F63-AF26-40F3E97216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2737" y="965497"/>
            <a:ext cx="6071616" cy="47914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88706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>
            <a:extLst>
              <a:ext uri="{FF2B5EF4-FFF2-40B4-BE49-F238E27FC236}">
                <a16:creationId xmlns:a16="http://schemas.microsoft.com/office/drawing/2014/main" id="{5829867F-A628-4285-8D2D-5D85B082CCC7}"/>
              </a:ext>
            </a:extLst>
          </p:cNvPr>
          <p:cNvSpPr/>
          <p:nvPr/>
        </p:nvSpPr>
        <p:spPr>
          <a:xfrm>
            <a:off x="282696" y="264599"/>
            <a:ext cx="9252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ea typeface="等线" panose="02010600030101010101" pitchFamily="2" charset="-122"/>
              </a:rPr>
              <a:t>Fig. S4</a:t>
            </a:r>
            <a:endParaRPr lang="zh-CN" altLang="en-US" sz="2000" dirty="0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332147F5-8826-4D8A-BF5C-3EED133138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053" y="1627408"/>
            <a:ext cx="7126842" cy="22252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51360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DC409BE6-71EC-4F6F-9281-01263A0A2C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2641" y="701040"/>
            <a:ext cx="4483657" cy="5566882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C72EE973-BC10-4EBA-ACE9-049987A6AF34}"/>
              </a:ext>
            </a:extLst>
          </p:cNvPr>
          <p:cNvSpPr/>
          <p:nvPr/>
        </p:nvSpPr>
        <p:spPr>
          <a:xfrm>
            <a:off x="282696" y="264599"/>
            <a:ext cx="9252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ea typeface="等线" panose="02010600030101010101" pitchFamily="2" charset="-122"/>
              </a:rPr>
              <a:t>Fig. S5</a:t>
            </a:r>
            <a:endParaRPr lang="zh-CN" altLang="en-US" sz="2000" dirty="0"/>
          </a:p>
        </p:txBody>
      </p:sp>
    </p:spTree>
    <p:extLst>
      <p:ext uri="{BB962C8B-B14F-4D97-AF65-F5344CB8AC3E}">
        <p14:creationId xmlns:p14="http://schemas.microsoft.com/office/powerpoint/2010/main" val="35445883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AEACE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AEACE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489</TotalTime>
  <Words>147</Words>
  <Application>Microsoft Office PowerPoint</Application>
  <PresentationFormat>全屏显示(4:3)</PresentationFormat>
  <Paragraphs>118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等线</vt:lpstr>
      <vt:lpstr>宋体</vt:lpstr>
      <vt:lpstr>Arial</vt:lpstr>
      <vt:lpstr>Calibri</vt:lpstr>
      <vt:lpstr>Calibri Light</vt:lpstr>
      <vt:lpstr>Times New Roman</vt:lpstr>
      <vt:lpstr>Office 主题</vt:lpstr>
      <vt:lpstr>Table S1. 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uckyfcf@163.com</cp:lastModifiedBy>
  <cp:revision>1363</cp:revision>
  <dcterms:created xsi:type="dcterms:W3CDTF">2017-10-24T09:26:00Z</dcterms:created>
  <dcterms:modified xsi:type="dcterms:W3CDTF">2022-10-08T08:22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023</vt:lpwstr>
  </property>
</Properties>
</file>